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34" autoAdjust="0"/>
  </p:normalViewPr>
  <p:slideViewPr>
    <p:cSldViewPr snapToGrid="0">
      <p:cViewPr varScale="1">
        <p:scale>
          <a:sx n="67" d="100"/>
          <a:sy n="67" d="100"/>
        </p:scale>
        <p:origin x="11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478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883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470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099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275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976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462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459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831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125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581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E0376-405A-475D-A640-A3A967668A8A}" type="datetimeFigureOut">
              <a:rPr kumimoji="1" lang="ja-JP" altLang="en-US" smtClean="0"/>
              <a:t>2022/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0D5B2-508F-43E5-90A1-30CF5DD39F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548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C5A5B9F-6E08-46AC-8424-FA05293209EF}"/>
              </a:ext>
            </a:extLst>
          </p:cNvPr>
          <p:cNvSpPr txBox="1"/>
          <p:nvPr/>
        </p:nvSpPr>
        <p:spPr>
          <a:xfrm>
            <a:off x="737303" y="5307378"/>
            <a:ext cx="8725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ja-JP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3 Relationship between the contact angle and roughness pitch of FPB-treated surfaces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05AE7AA-EE90-4677-AE0F-0DED7D4FBD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7301" y="1021519"/>
            <a:ext cx="6151397" cy="4285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7967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</TotalTime>
  <Words>15</Words>
  <Application>Microsoft Office PowerPoint</Application>
  <PresentationFormat>A4 210 x 297 mm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dama nishitani tomoko</dc:creator>
  <cp:lastModifiedBy>kodama nishitani tomoko</cp:lastModifiedBy>
  <cp:revision>5</cp:revision>
  <dcterms:created xsi:type="dcterms:W3CDTF">2022-01-10T01:23:09Z</dcterms:created>
  <dcterms:modified xsi:type="dcterms:W3CDTF">2022-01-20T00:39:42Z</dcterms:modified>
</cp:coreProperties>
</file>